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302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28" userDrawn="1">
          <p15:clr>
            <a:srgbClr val="A4A3A4"/>
          </p15:clr>
        </p15:guide>
        <p15:guide id="2" pos="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  <a:srgbClr val="CC99FF"/>
    <a:srgbClr val="717FD9"/>
    <a:srgbClr val="5A6C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1C5804-9819-413C-9FE0-72C9A12AF2AB}" v="1" dt="2024-05-09T19:18:02.77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794" y="96"/>
      </p:cViewPr>
      <p:guideLst>
        <p:guide orient="horz" pos="4128"/>
        <p:guide pos="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buckeyemailosu-my.sharepoint.com/personal/patel_3410_osu_edu/Documents/TCGA_Significant%200.2+direction%20list%20and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J$17:$J$32</c:f>
              <c:strCache>
                <c:ptCount val="16"/>
                <c:pt idx="0">
                  <c:v>Healthy</c:v>
                </c:pt>
                <c:pt idx="1">
                  <c:v>LUAD -N</c:v>
                </c:pt>
                <c:pt idx="2">
                  <c:v>LUAD-T</c:v>
                </c:pt>
                <c:pt idx="3">
                  <c:v>LUSC -N</c:v>
                </c:pt>
                <c:pt idx="4">
                  <c:v>LUSC-T</c:v>
                </c:pt>
                <c:pt idx="5">
                  <c:v>LUAD -N, LUAD-T</c:v>
                </c:pt>
                <c:pt idx="6">
                  <c:v>LUAD -N, LUSC -N</c:v>
                </c:pt>
                <c:pt idx="7">
                  <c:v>LUAD -N, LUSC-T</c:v>
                </c:pt>
                <c:pt idx="8">
                  <c:v>LUAD-T, LUSC -N</c:v>
                </c:pt>
                <c:pt idx="9">
                  <c:v>LUAD-T, LUSC -T</c:v>
                </c:pt>
                <c:pt idx="10">
                  <c:v>LUSC -N, LUSC-T</c:v>
                </c:pt>
                <c:pt idx="11">
                  <c:v>LUAD -N, LUAD-T, LUSC -N, LUSC-T</c:v>
                </c:pt>
                <c:pt idx="12">
                  <c:v>LUAD -N, LUAD-T, LUSC -N</c:v>
                </c:pt>
                <c:pt idx="13">
                  <c:v>LUAD -N, LUSC -N, LUSC-T</c:v>
                </c:pt>
                <c:pt idx="14">
                  <c:v>LUAD-T, LUSC -N, LUSC -T</c:v>
                </c:pt>
                <c:pt idx="15">
                  <c:v>LUAD -N, LUAD-T, LUSC-T</c:v>
                </c:pt>
              </c:strCache>
            </c:strRef>
          </c:cat>
          <c:val>
            <c:numRef>
              <c:f>Sheet1!$K$17:$K$32</c:f>
              <c:numCache>
                <c:formatCode>General</c:formatCode>
                <c:ptCount val="16"/>
                <c:pt idx="0">
                  <c:v>44</c:v>
                </c:pt>
                <c:pt idx="1">
                  <c:v>4</c:v>
                </c:pt>
                <c:pt idx="2">
                  <c:v>3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4</c:v>
                </c:pt>
                <c:pt idx="7">
                  <c:v>4</c:v>
                </c:pt>
                <c:pt idx="8">
                  <c:v>11</c:v>
                </c:pt>
                <c:pt idx="9">
                  <c:v>28</c:v>
                </c:pt>
                <c:pt idx="10">
                  <c:v>4</c:v>
                </c:pt>
                <c:pt idx="11">
                  <c:v>57</c:v>
                </c:pt>
                <c:pt idx="12">
                  <c:v>15</c:v>
                </c:pt>
                <c:pt idx="13">
                  <c:v>2</c:v>
                </c:pt>
                <c:pt idx="14">
                  <c:v>28</c:v>
                </c:pt>
                <c:pt idx="15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D4-4362-AC05-DCFD3A19FE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8783024"/>
        <c:axId val="548783440"/>
      </c:barChart>
      <c:catAx>
        <c:axId val="5487830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8783440"/>
        <c:crosses val="autoZero"/>
        <c:auto val="1"/>
        <c:lblAlgn val="ctr"/>
        <c:lblOffset val="100"/>
        <c:noMultiLvlLbl val="0"/>
      </c:catAx>
      <c:valAx>
        <c:axId val="5487834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8783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CC99BA-A399-47A7-97B4-EDE45F73F8AF}" type="datetimeFigureOut">
              <a:t>5/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3B737E-BB33-475A-A4BF-F5F49D6005A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231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904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63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39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725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339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833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696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48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01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616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368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85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232180E-B8DE-1270-B858-803B9983B4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5348249"/>
              </p:ext>
            </p:extLst>
          </p:nvPr>
        </p:nvGraphicFramePr>
        <p:xfrm>
          <a:off x="868219" y="4079580"/>
          <a:ext cx="7730834" cy="658675"/>
        </p:xfrm>
        <a:graphic>
          <a:graphicData uri="http://schemas.openxmlformats.org/drawingml/2006/table">
            <a:tbl>
              <a:tblPr bandCol="1">
                <a:tableStyleId>{073A0DAA-6AF3-43AB-8588-CEC1D06C72B9}</a:tableStyleId>
              </a:tblPr>
              <a:tblGrid>
                <a:gridCol w="853010">
                  <a:extLst>
                    <a:ext uri="{9D8B030D-6E8A-4147-A177-3AD203B41FA5}">
                      <a16:colId xmlns:a16="http://schemas.microsoft.com/office/drawing/2014/main" val="2447272917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71513851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1737570587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3483405712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1440868713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2589829882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2066157018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828620958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1579369090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1453472820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2842686938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106536410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608305255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2320132423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1326910760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487193667"/>
                    </a:ext>
                  </a:extLst>
                </a:gridCol>
                <a:gridCol w="429864">
                  <a:extLst>
                    <a:ext uri="{9D8B030D-6E8A-4147-A177-3AD203B41FA5}">
                      <a16:colId xmlns:a16="http://schemas.microsoft.com/office/drawing/2014/main" val="147123783"/>
                    </a:ext>
                  </a:extLst>
                </a:gridCol>
              </a:tblGrid>
              <a:tr h="1317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-Healthy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extLst>
                  <a:ext uri="{0D108BD9-81ED-4DB2-BD59-A6C34878D82A}">
                    <a16:rowId xmlns:a16="http://schemas.microsoft.com/office/drawing/2014/main" val="1349550535"/>
                  </a:ext>
                </a:extLst>
              </a:tr>
              <a:tr h="1317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AD-N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extLst>
                  <a:ext uri="{0D108BD9-81ED-4DB2-BD59-A6C34878D82A}">
                    <a16:rowId xmlns:a16="http://schemas.microsoft.com/office/drawing/2014/main" val="1359563075"/>
                  </a:ext>
                </a:extLst>
              </a:tr>
              <a:tr h="1317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AD-T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extLst>
                  <a:ext uri="{0D108BD9-81ED-4DB2-BD59-A6C34878D82A}">
                    <a16:rowId xmlns:a16="http://schemas.microsoft.com/office/drawing/2014/main" val="1186146610"/>
                  </a:ext>
                </a:extLst>
              </a:tr>
              <a:tr h="1317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SC-N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extLst>
                  <a:ext uri="{0D108BD9-81ED-4DB2-BD59-A6C34878D82A}">
                    <a16:rowId xmlns:a16="http://schemas.microsoft.com/office/drawing/2014/main" val="1149058786"/>
                  </a:ext>
                </a:extLst>
              </a:tr>
              <a:tr h="1317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SC-T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4" marR="6854" marT="6854" marB="0" anchor="b"/>
                </a:tc>
                <a:extLst>
                  <a:ext uri="{0D108BD9-81ED-4DB2-BD59-A6C34878D82A}">
                    <a16:rowId xmlns:a16="http://schemas.microsoft.com/office/drawing/2014/main" val="3608085085"/>
                  </a:ext>
                </a:extLst>
              </a:tr>
            </a:tbl>
          </a:graphicData>
        </a:graphic>
      </p:graphicFrame>
      <p:grpSp>
        <p:nvGrpSpPr>
          <p:cNvPr id="6" name="Group 5">
            <a:extLst>
              <a:ext uri="{FF2B5EF4-FFF2-40B4-BE49-F238E27FC236}">
                <a16:creationId xmlns:a16="http://schemas.microsoft.com/office/drawing/2014/main" id="{6CD0D603-8A70-6DE1-4BE3-68396A0D8397}"/>
              </a:ext>
            </a:extLst>
          </p:cNvPr>
          <p:cNvGrpSpPr/>
          <p:nvPr/>
        </p:nvGrpSpPr>
        <p:grpSpPr>
          <a:xfrm>
            <a:off x="0" y="0"/>
            <a:ext cx="9809825" cy="4139262"/>
            <a:chOff x="0" y="0"/>
            <a:chExt cx="9809825" cy="4139262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6A3C59D4-3BF0-69C7-0443-6E99492332B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59576242"/>
                </p:ext>
              </p:extLst>
            </p:nvPr>
          </p:nvGraphicFramePr>
          <p:xfrm>
            <a:off x="1403927" y="1000773"/>
            <a:ext cx="7287492" cy="31384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278118B-F689-DDD7-481F-DD0B1A48C1A6}"/>
                </a:ext>
              </a:extLst>
            </p:cNvPr>
            <p:cNvSpPr txBox="1"/>
            <p:nvPr/>
          </p:nvSpPr>
          <p:spPr>
            <a:xfrm rot="16200000">
              <a:off x="-320190" y="2251108"/>
              <a:ext cx="29072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>
                  <a:latin typeface="Arial" panose="020B0604020202020204" pitchFamily="34" charset="0"/>
                  <a:cs typeface="Arial" panose="020B0604020202020204" pitchFamily="34" charset="0"/>
                </a:rPr>
                <a:t># of significant DM-CpGs matched in the direction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40072E2-A3AA-4728-2929-B7E29256D849}"/>
                </a:ext>
              </a:extLst>
            </p:cNvPr>
            <p:cNvSpPr txBox="1"/>
            <p:nvPr/>
          </p:nvSpPr>
          <p:spPr>
            <a:xfrm>
              <a:off x="0" y="0"/>
              <a:ext cx="9809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Supplementary Figure 1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13876D15-51CB-2D6C-56B8-ED53BAE2B037}"/>
              </a:ext>
            </a:extLst>
          </p:cNvPr>
          <p:cNvSpPr txBox="1"/>
          <p:nvPr/>
        </p:nvSpPr>
        <p:spPr>
          <a:xfrm>
            <a:off x="988056" y="5219375"/>
            <a:ext cx="74911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Supplementary Figure 1. Significant sex-related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CpGs</a:t>
            </a:r>
            <a:r>
              <a:rPr lang="en-US" sz="1200" b="1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 overlap between tissue types. </a:t>
            </a:r>
            <a:r>
              <a:rPr lang="en-US" sz="12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Number of significant sex-related </a:t>
            </a:r>
            <a:r>
              <a:rPr lang="en-US" sz="1200" dirty="0" err="1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CpGs</a:t>
            </a:r>
            <a:r>
              <a:rPr lang="en-US" sz="12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.</a:t>
            </a:r>
            <a:r>
              <a:rPr lang="en-US" sz="1200" b="1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Each X in the scale indicates which datasets are being compared. The number above the bars indicates the overlapping </a:t>
            </a:r>
            <a:r>
              <a:rPr lang="en-US" sz="1200" dirty="0" err="1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CpGs</a:t>
            </a:r>
            <a:r>
              <a:rPr lang="en-US" sz="1200" dirty="0">
                <a:effectLst/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 in the same direction.</a:t>
            </a:r>
            <a:endParaRPr lang="en-US" sz="1200" dirty="0">
              <a:effectLst/>
              <a:latin typeface="Calibri" panose="020F0502020204030204" pitchFamily="34" charset="0"/>
              <a:ea typeface="Batang" panose="02030600000101010101" pitchFamily="18" charset="-127"/>
              <a:cs typeface="Arial" panose="020B0604020202020204" pitchFamily="34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74041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40AAA7FAA148E4FA340028D2E257C42" ma:contentTypeVersion="13" ma:contentTypeDescription="Create a new document." ma:contentTypeScope="" ma:versionID="25ad279836efa501d5a89342109e698b">
  <xsd:schema xmlns:xsd="http://www.w3.org/2001/XMLSchema" xmlns:xs="http://www.w3.org/2001/XMLSchema" xmlns:p="http://schemas.microsoft.com/office/2006/metadata/properties" xmlns:ns2="cd92047d-538e-4dc6-8624-0052cd70ff9e" xmlns:ns3="0f190277-1b12-49e0-a670-3dfa0a185ba8" targetNamespace="http://schemas.microsoft.com/office/2006/metadata/properties" ma:root="true" ma:fieldsID="5de8fa02d88bb0f77772f182d5bff18a" ns2:_="" ns3:_="">
    <xsd:import namespace="cd92047d-538e-4dc6-8624-0052cd70ff9e"/>
    <xsd:import namespace="0f190277-1b12-49e0-a670-3dfa0a185ba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d92047d-538e-4dc6-8624-0052cd70ff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7b434354-605c-4a24-9fd5-b21458dd13e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f190277-1b12-49e0-a670-3dfa0a185ba8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7" nillable="true" ma:displayName="Taxonomy Catch All Column" ma:hidden="true" ma:list="{35a633d6-c66e-4c5c-9abe-feae28b6f3c3}" ma:internalName="TaxCatchAll" ma:showField="CatchAllData" ma:web="0f190277-1b12-49e0-a670-3dfa0a185ba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0f190277-1b12-49e0-a670-3dfa0a185ba8" xsi:nil="true"/>
    <lcf76f155ced4ddcb4097134ff3c332f xmlns="cd92047d-538e-4dc6-8624-0052cd70ff9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B6505A63-D924-46BD-A222-BBD54C98703D}">
  <ds:schemaRefs>
    <ds:schemaRef ds:uri="0f190277-1b12-49e0-a670-3dfa0a185ba8"/>
    <ds:schemaRef ds:uri="cd92047d-538e-4dc6-8624-0052cd70ff9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9B9CA7D8-47F4-4EEE-9CD5-81F05A6211E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05D957B-7F54-442F-96CF-1FA52FE73CC3}">
  <ds:schemaRefs>
    <ds:schemaRef ds:uri="0f190277-1b12-49e0-a670-3dfa0a185ba8"/>
    <ds:schemaRef ds:uri="cd92047d-538e-4dc6-8624-0052cd70ff9e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852</TotalTime>
  <Words>108</Words>
  <Application>Microsoft Office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Song, Min-Ae</cp:lastModifiedBy>
  <cp:revision>8</cp:revision>
  <dcterms:created xsi:type="dcterms:W3CDTF">2022-05-16T19:14:45Z</dcterms:created>
  <dcterms:modified xsi:type="dcterms:W3CDTF">2024-05-09T19:18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40AAA7FAA148E4FA340028D2E257C42</vt:lpwstr>
  </property>
  <property fmtid="{D5CDD505-2E9C-101B-9397-08002B2CF9AE}" pid="3" name="MediaServiceImageTags">
    <vt:lpwstr/>
  </property>
</Properties>
</file>